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3DA7424-F72B-1EB5-697F-CA9333E57F0A}" name="PhilR" initials="PJR" userId="PhilR" providerId="None"/>
  <p188:author id="{3B063878-6895-4B8D-823B-C7D9104357F1}" name="Roger Reddel" initials="RR" userId="S::rreddel@cmri.org.au::750bfe6e-02cc-4cce-a1ed-bde13e6cbbb1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713" autoAdjust="0"/>
    <p:restoredTop sz="95748" autoAdjust="0"/>
  </p:normalViewPr>
  <p:slideViewPr>
    <p:cSldViewPr snapToGrid="0">
      <p:cViewPr varScale="1">
        <p:scale>
          <a:sx n="69" d="100"/>
          <a:sy n="69" d="100"/>
        </p:scale>
        <p:origin x="230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BFE566-B291-6C40-A8EB-8EA7FEA7A444}" type="datetimeFigureOut">
              <a:rPr lang="en-US" smtClean="0"/>
              <a:t>2/2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0A3A11-C076-CF4F-B186-F8DBC4F2A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9790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89312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20091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56602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032826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24586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65390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51120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661832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51821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813198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597190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35162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A161CCB-5793-14BE-9BAC-BBB0FEA5687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068" y="4599021"/>
            <a:ext cx="6584254" cy="297598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FCAA9DE-B0B2-FDBD-8AC3-B5665ACB917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068" y="1128272"/>
            <a:ext cx="6584254" cy="277143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2744DD4-DB9B-4B2B-AFA2-F91E31D8B5EC}"/>
              </a:ext>
            </a:extLst>
          </p:cNvPr>
          <p:cNvSpPr txBox="1"/>
          <p:nvPr/>
        </p:nvSpPr>
        <p:spPr>
          <a:xfrm>
            <a:off x="235968" y="504468"/>
            <a:ext cx="529955" cy="4285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</a:pPr>
            <a:r>
              <a:rPr lang="en-US" sz="2300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en-AU" sz="2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5161221-CC6F-45C5-BCAF-CCFC7497EB4C}"/>
              </a:ext>
            </a:extLst>
          </p:cNvPr>
          <p:cNvSpPr txBox="1"/>
          <p:nvPr/>
        </p:nvSpPr>
        <p:spPr>
          <a:xfrm>
            <a:off x="235968" y="3871995"/>
            <a:ext cx="529955" cy="4285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</a:pPr>
            <a:r>
              <a:rPr lang="en-US" sz="2300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lang="en-AU" sz="2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0BB4DAD-5840-4FA9-889E-54EFA3183BD3}"/>
              </a:ext>
            </a:extLst>
          </p:cNvPr>
          <p:cNvSpPr txBox="1"/>
          <p:nvPr/>
        </p:nvSpPr>
        <p:spPr>
          <a:xfrm>
            <a:off x="618437" y="578171"/>
            <a:ext cx="6180570" cy="6186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athways for 2,816 peptides (1,218 proteins) up-regulated in tumor</a:t>
            </a:r>
            <a:endParaRPr lang="en-A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FBE9733-62C8-47A4-B1D7-291F75AFFCBD}"/>
              </a:ext>
            </a:extLst>
          </p:cNvPr>
          <p:cNvSpPr txBox="1"/>
          <p:nvPr/>
        </p:nvSpPr>
        <p:spPr>
          <a:xfrm>
            <a:off x="618437" y="3949777"/>
            <a:ext cx="6180571" cy="6186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athways for 2,018 peptides (396 proteins) down-regulated in tumor</a:t>
            </a:r>
            <a:endParaRPr lang="en-A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E792C41-3E1C-94AD-DEAD-5446E61CA5C6}"/>
              </a:ext>
            </a:extLst>
          </p:cNvPr>
          <p:cNvSpPr txBox="1"/>
          <p:nvPr/>
        </p:nvSpPr>
        <p:spPr>
          <a:xfrm>
            <a:off x="117984" y="7745814"/>
            <a:ext cx="6740016" cy="201593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AU" sz="1200" b="1" dirty="0">
                <a:effectLst/>
                <a:latin typeface="Calibri" panose="020F0502020204030204" pitchFamily="34" charset="0"/>
                <a:ea typeface="DengXian Light" panose="02010600030101010101" pitchFamily="2" charset="-122"/>
                <a:cs typeface="Times New Roman" panose="02020603050405020304" pitchFamily="18" charset="0"/>
              </a:rPr>
              <a:t>Supplementary Figure S2: Top 15 cellular functions and pathways for DAPeps in </a:t>
            </a:r>
            <a:r>
              <a:rPr lang="en-AU" sz="1200" b="1" dirty="0" err="1">
                <a:effectLst/>
                <a:latin typeface="Calibri" panose="020F0502020204030204" pitchFamily="34" charset="0"/>
                <a:ea typeface="DengXian Light" panose="02010600030101010101" pitchFamily="2" charset="-122"/>
                <a:cs typeface="Times New Roman" panose="02020603050405020304" pitchFamily="18" charset="0"/>
              </a:rPr>
              <a:t>tumor</a:t>
            </a:r>
            <a:r>
              <a:rPr lang="en-AU" sz="1200" b="1" dirty="0">
                <a:effectLst/>
                <a:latin typeface="Calibri" panose="020F0502020204030204" pitchFamily="34" charset="0"/>
                <a:ea typeface="DengXian Light" panose="02010600030101010101" pitchFamily="2" charset="-122"/>
                <a:cs typeface="Times New Roman" panose="02020603050405020304" pitchFamily="18" charset="0"/>
              </a:rPr>
              <a:t> vs to NAT samples</a:t>
            </a:r>
          </a:p>
          <a:p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mpacted pathways were analyzed separately for the </a:t>
            </a:r>
            <a:r>
              <a:rPr lang="en-AU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up-regulated or </a:t>
            </a:r>
            <a:r>
              <a:rPr lang="en-AU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down-regulated proteins associated with the DAPeps according to the number of proteins in that function (# genes) and </a:t>
            </a:r>
            <a:r>
              <a:rPr lang="en-AU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olored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ccording to the adjusted p-value.  Pathways were identified for 2,816 peptides (1,218 unique proteins) up-regulated in </a:t>
            </a:r>
            <a:r>
              <a:rPr lang="en-AU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umor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or 2,018 peptides (396 proteins) down-regulated in </a:t>
            </a:r>
            <a:r>
              <a:rPr lang="en-AU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umor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 Pathways up-regulated in the tumors include 971 GO Biological Processes, 83 KEGG Pathways and 413 </a:t>
            </a:r>
            <a:r>
              <a:rPr lang="en-AU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actome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Pathways, and those down-regulated include </a:t>
            </a:r>
            <a:r>
              <a:rPr lang="en-AU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428 GO Biological Processes, 24 KEGG Pathways and 93 </a:t>
            </a:r>
            <a:r>
              <a:rPr lang="en-AU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actome</a:t>
            </a:r>
            <a:r>
              <a:rPr lang="en-AU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Pathways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</a:p>
          <a:p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B6D6C0E-9570-2335-1E21-260C6C95986C}"/>
              </a:ext>
            </a:extLst>
          </p:cNvPr>
          <p:cNvSpPr txBox="1"/>
          <p:nvPr/>
        </p:nvSpPr>
        <p:spPr>
          <a:xfrm>
            <a:off x="262702" y="26393"/>
            <a:ext cx="3996814" cy="3262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  <a:endParaRPr lang="en-AU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75490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895</TotalTime>
  <Words>148</Words>
  <Application>Microsoft Office PowerPoint</Application>
  <PresentationFormat>A4 Paper (210x297 mm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hilR</dc:creator>
  <cp:lastModifiedBy>PhilR</cp:lastModifiedBy>
  <cp:revision>325</cp:revision>
  <dcterms:created xsi:type="dcterms:W3CDTF">2022-08-07T22:18:57Z</dcterms:created>
  <dcterms:modified xsi:type="dcterms:W3CDTF">2025-02-23T23:01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XPowerLiteLastOptimized">
    <vt:lpwstr>4123633</vt:lpwstr>
  </property>
  <property fmtid="{D5CDD505-2E9C-101B-9397-08002B2CF9AE}" pid="3" name="NXPowerLiteSettings">
    <vt:lpwstr>E9000A40064001</vt:lpwstr>
  </property>
  <property fmtid="{D5CDD505-2E9C-101B-9397-08002B2CF9AE}" pid="4" name="NXPowerLiteVersion">
    <vt:lpwstr>D9.1.2</vt:lpwstr>
  </property>
</Properties>
</file>